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淡色スタイル 1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8799B23B-EC83-4686-B30A-512413B5E67A}" styleName="淡色スタイル 3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F2DE63D5-997A-4646-A377-4702673A728D}" styleName="淡色スタイル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57" autoAdjust="0"/>
    <p:restoredTop sz="88965" autoAdjust="0"/>
  </p:normalViewPr>
  <p:slideViewPr>
    <p:cSldViewPr snapToGrid="0">
      <p:cViewPr varScale="1">
        <p:scale>
          <a:sx n="66" d="100"/>
          <a:sy n="66" d="100"/>
        </p:scale>
        <p:origin x="74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袖野 美穂/SODENO Miho" userId="013d5c9f-92f5-4661-9e91-da806e7982b3" providerId="ADAL" clId="{C47FC29D-2090-4563-8B21-06ED7AFEA9DE}"/>
    <pc:docChg chg="delSld">
      <pc:chgData name="袖野 美穂/SODENO Miho" userId="013d5c9f-92f5-4661-9e91-da806e7982b3" providerId="ADAL" clId="{C47FC29D-2090-4563-8B21-06ED7AFEA9DE}" dt="2025-07-07T17:14:38.701" v="6" actId="47"/>
      <pc:docMkLst>
        <pc:docMk/>
      </pc:docMkLst>
      <pc:sldChg chg="del">
        <pc:chgData name="袖野 美穂/SODENO Miho" userId="013d5c9f-92f5-4661-9e91-da806e7982b3" providerId="ADAL" clId="{C47FC29D-2090-4563-8B21-06ED7AFEA9DE}" dt="2025-07-07T17:14:34.069" v="1" actId="47"/>
        <pc:sldMkLst>
          <pc:docMk/>
          <pc:sldMk cId="2402741190" sldId="269"/>
        </pc:sldMkLst>
      </pc:sldChg>
      <pc:sldChg chg="del">
        <pc:chgData name="袖野 美穂/SODENO Miho" userId="013d5c9f-92f5-4661-9e91-da806e7982b3" providerId="ADAL" clId="{C47FC29D-2090-4563-8B21-06ED7AFEA9DE}" dt="2025-07-07T17:14:35.469" v="2" actId="47"/>
        <pc:sldMkLst>
          <pc:docMk/>
          <pc:sldMk cId="1931122243" sldId="270"/>
        </pc:sldMkLst>
      </pc:sldChg>
      <pc:sldChg chg="del">
        <pc:chgData name="袖野 美穂/SODENO Miho" userId="013d5c9f-92f5-4661-9e91-da806e7982b3" providerId="ADAL" clId="{C47FC29D-2090-4563-8B21-06ED7AFEA9DE}" dt="2025-07-07T17:14:37.768" v="4" actId="47"/>
        <pc:sldMkLst>
          <pc:docMk/>
          <pc:sldMk cId="1281285728" sldId="271"/>
        </pc:sldMkLst>
      </pc:sldChg>
      <pc:sldChg chg="del">
        <pc:chgData name="袖野 美穂/SODENO Miho" userId="013d5c9f-92f5-4661-9e91-da806e7982b3" providerId="ADAL" clId="{C47FC29D-2090-4563-8B21-06ED7AFEA9DE}" dt="2025-07-07T17:14:38.701" v="6" actId="47"/>
        <pc:sldMkLst>
          <pc:docMk/>
          <pc:sldMk cId="2331672233" sldId="273"/>
        </pc:sldMkLst>
      </pc:sldChg>
      <pc:sldChg chg="del">
        <pc:chgData name="袖野 美穂/SODENO Miho" userId="013d5c9f-92f5-4661-9e91-da806e7982b3" providerId="ADAL" clId="{C47FC29D-2090-4563-8B21-06ED7AFEA9DE}" dt="2025-07-07T17:14:36.926" v="3" actId="47"/>
        <pc:sldMkLst>
          <pc:docMk/>
          <pc:sldMk cId="988128021" sldId="274"/>
        </pc:sldMkLst>
      </pc:sldChg>
      <pc:sldChg chg="del">
        <pc:chgData name="袖野 美穂/SODENO Miho" userId="013d5c9f-92f5-4661-9e91-da806e7982b3" providerId="ADAL" clId="{C47FC29D-2090-4563-8B21-06ED7AFEA9DE}" dt="2025-07-07T17:14:33.061" v="0" actId="47"/>
        <pc:sldMkLst>
          <pc:docMk/>
          <pc:sldMk cId="2524183646" sldId="275"/>
        </pc:sldMkLst>
      </pc:sldChg>
      <pc:sldChg chg="del">
        <pc:chgData name="袖野 美穂/SODENO Miho" userId="013d5c9f-92f5-4661-9e91-da806e7982b3" providerId="ADAL" clId="{C47FC29D-2090-4563-8B21-06ED7AFEA9DE}" dt="2025-07-07T17:14:38.201" v="5" actId="47"/>
        <pc:sldMkLst>
          <pc:docMk/>
          <pc:sldMk cId="127998114" sldId="28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479992-0F21-43C5-BA7F-0E120BA746B5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D6507C-F102-400E-9FB0-E718D8991D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5913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464166-24D6-BD56-45D3-D0E3EAFF4F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1" y="1122363"/>
            <a:ext cx="9144000" cy="2387600"/>
          </a:xfrm>
        </p:spPr>
        <p:txBody>
          <a:bodyPr anchor="b"/>
          <a:lstStyle>
            <a:lvl1pPr algn="ctr">
              <a:defRPr sz="6002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8B101F0-61C3-F262-27E8-C34AC27CA4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1" y="3602038"/>
            <a:ext cx="9144000" cy="1655762"/>
          </a:xfrm>
        </p:spPr>
        <p:txBody>
          <a:bodyPr/>
          <a:lstStyle>
            <a:lvl1pPr marL="0" indent="0" algn="ctr">
              <a:buNone/>
              <a:defRPr sz="2401"/>
            </a:lvl1pPr>
            <a:lvl2pPr marL="457251" indent="0" algn="ctr">
              <a:buNone/>
              <a:defRPr sz="2000"/>
            </a:lvl2pPr>
            <a:lvl3pPr marL="914504" indent="0" algn="ctr">
              <a:buNone/>
              <a:defRPr sz="1801"/>
            </a:lvl3pPr>
            <a:lvl4pPr marL="1371754" indent="0" algn="ctr">
              <a:buNone/>
              <a:defRPr sz="1600"/>
            </a:lvl4pPr>
            <a:lvl5pPr marL="1829006" indent="0" algn="ctr">
              <a:buNone/>
              <a:defRPr sz="1600"/>
            </a:lvl5pPr>
            <a:lvl6pPr marL="2286257" indent="0" algn="ctr">
              <a:buNone/>
              <a:defRPr sz="1600"/>
            </a:lvl6pPr>
            <a:lvl7pPr marL="2743507" indent="0" algn="ctr">
              <a:buNone/>
              <a:defRPr sz="1600"/>
            </a:lvl7pPr>
            <a:lvl8pPr marL="3200760" indent="0" algn="ctr">
              <a:buNone/>
              <a:defRPr sz="1600"/>
            </a:lvl8pPr>
            <a:lvl9pPr marL="365801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6873646-814D-139E-6EBC-D073E8684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627498A-25F5-EEDF-8800-A6ED181387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9EE125-A281-D6E6-C2CB-708E3B1F5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707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2AEE02-8DCC-D31E-9C3A-2B865A3A06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2592D87-4519-2A77-23C7-BF77B84B36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F3C872-9C8F-D98D-5B56-094CC4BB77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926A48A-1030-7439-157F-79A8E85DCB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CA90D9C-646E-735C-3901-3AFD8402C9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793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A8E2D1E-0C26-1B93-9C71-F760F5A0EF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B2D0B81-163A-619A-3E66-35672D1209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29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569942-6514-EA79-0310-DD7B85AB0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C3043B-90EC-781B-0834-C6BD4C745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5FDAFFE-DC5E-1A14-03AE-49F58B9C9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331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EE33C9-3A79-14B6-8829-F6515FBE39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61D083F-9BCC-3595-AE1A-ED073B3B60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4F5A1A8-C56D-9B89-6CD3-1D0050D0FF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FBFAE5F-00C6-642B-A986-D3FD1F4CAA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4BADFE-B366-034B-59F7-B3F32D2C2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708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C698AC6-434B-C655-F844-0CE34F6E8D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3" y="1709741"/>
            <a:ext cx="10515601" cy="2852737"/>
          </a:xfrm>
        </p:spPr>
        <p:txBody>
          <a:bodyPr anchor="b"/>
          <a:lstStyle>
            <a:lvl1pPr>
              <a:defRPr sz="6002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D38158F-CA22-188C-62EC-D4D856D379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3" y="4589465"/>
            <a:ext cx="10515601" cy="1500187"/>
          </a:xfrm>
        </p:spPr>
        <p:txBody>
          <a:bodyPr/>
          <a:lstStyle>
            <a:lvl1pPr marL="0" indent="0">
              <a:buNone/>
              <a:defRPr sz="2401">
                <a:solidFill>
                  <a:schemeClr val="tx1">
                    <a:tint val="75000"/>
                  </a:schemeClr>
                </a:solidFill>
              </a:defRPr>
            </a:lvl1pPr>
            <a:lvl2pPr marL="45725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504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900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2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50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801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8524BC6-6CAF-3716-52C8-DE451FCFD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66D899F-9B7A-FC89-1F38-E97237ECE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3E77B89-2798-1C40-97DB-9DBC24B65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4130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F88BD6-EA98-48B6-2C27-04A635E5FE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E5D0FEC-6E52-927E-E2BF-D4C29721F4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3" y="1825626"/>
            <a:ext cx="5181601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DA89C7D-957F-E13F-F6E1-4241384CA3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2" y="1825626"/>
            <a:ext cx="5181601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728B545-288E-AF55-1223-90321DED9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421AE36-EB79-8630-8E33-5F84D56A21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0FD20AF-A0DE-83B5-B7CD-FB04BEA7B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541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B5474C-D259-AA88-4146-0E7A2CC1B5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365128"/>
            <a:ext cx="10515601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53A3D25-A598-6255-2247-1CB293245E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7" y="1681163"/>
            <a:ext cx="5157788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251" indent="0">
              <a:buNone/>
              <a:defRPr sz="2000" b="1"/>
            </a:lvl2pPr>
            <a:lvl3pPr marL="914504" indent="0">
              <a:buNone/>
              <a:defRPr sz="1801" b="1"/>
            </a:lvl3pPr>
            <a:lvl4pPr marL="1371754" indent="0">
              <a:buNone/>
              <a:defRPr sz="1600" b="1"/>
            </a:lvl4pPr>
            <a:lvl5pPr marL="1829006" indent="0">
              <a:buNone/>
              <a:defRPr sz="1600" b="1"/>
            </a:lvl5pPr>
            <a:lvl6pPr marL="2286257" indent="0">
              <a:buNone/>
              <a:defRPr sz="1600" b="1"/>
            </a:lvl6pPr>
            <a:lvl7pPr marL="2743507" indent="0">
              <a:buNone/>
              <a:defRPr sz="1600" b="1"/>
            </a:lvl7pPr>
            <a:lvl8pPr marL="3200760" indent="0">
              <a:buNone/>
              <a:defRPr sz="1600" b="1"/>
            </a:lvl8pPr>
            <a:lvl9pPr marL="365801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41BCCC0-2795-E539-B68B-DE110973A3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7" y="2505075"/>
            <a:ext cx="51577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AF0E546-E806-FCFD-310A-35DC04EE92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199" y="1681163"/>
            <a:ext cx="5183189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251" indent="0">
              <a:buNone/>
              <a:defRPr sz="2000" b="1"/>
            </a:lvl2pPr>
            <a:lvl3pPr marL="914504" indent="0">
              <a:buNone/>
              <a:defRPr sz="1801" b="1"/>
            </a:lvl3pPr>
            <a:lvl4pPr marL="1371754" indent="0">
              <a:buNone/>
              <a:defRPr sz="1600" b="1"/>
            </a:lvl4pPr>
            <a:lvl5pPr marL="1829006" indent="0">
              <a:buNone/>
              <a:defRPr sz="1600" b="1"/>
            </a:lvl5pPr>
            <a:lvl6pPr marL="2286257" indent="0">
              <a:buNone/>
              <a:defRPr sz="1600" b="1"/>
            </a:lvl6pPr>
            <a:lvl7pPr marL="2743507" indent="0">
              <a:buNone/>
              <a:defRPr sz="1600" b="1"/>
            </a:lvl7pPr>
            <a:lvl8pPr marL="3200760" indent="0">
              <a:buNone/>
              <a:defRPr sz="1600" b="1"/>
            </a:lvl8pPr>
            <a:lvl9pPr marL="365801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414CC94-18E7-D95F-6C65-3FB4581C38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199" y="2505075"/>
            <a:ext cx="5183189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D52D1EE-9BE4-1205-8DCC-1DE2F5A83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53598D0-1A6B-670C-0BF0-18CD151F9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BAB580F-C925-340C-8CCA-A3FC926B1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866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C7D32FE-3D50-FD48-FC87-A2599E2AD4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E3A9190-3726-4C62-9FAD-953C1CA257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45A14A8-A3FE-EEBA-281C-12C44BEC95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5E39E7E-A737-8798-DE24-CF16C3792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3308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D2E5DAD-DAA3-79E3-113B-80B35AB13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ED156AA-C8E1-13B5-6110-365D548DC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0E9B701-8EA4-F360-4B2C-3CDCFBD54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68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25B66D-E2A7-E9A0-B650-B75A01CA54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9592B43-42DC-0A49-D02D-2850D4EBFB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92" y="987428"/>
            <a:ext cx="6172199" cy="4873625"/>
          </a:xfrm>
        </p:spPr>
        <p:txBody>
          <a:bodyPr/>
          <a:lstStyle>
            <a:lvl1pPr>
              <a:defRPr sz="3200"/>
            </a:lvl1pPr>
            <a:lvl2pPr>
              <a:defRPr sz="2801"/>
            </a:lvl2pPr>
            <a:lvl3pPr>
              <a:defRPr sz="2401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1888D10-42CF-524B-AC75-1FCB8CBB12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51" indent="0">
              <a:buNone/>
              <a:defRPr sz="1401"/>
            </a:lvl2pPr>
            <a:lvl3pPr marL="914504" indent="0">
              <a:buNone/>
              <a:defRPr sz="1199"/>
            </a:lvl3pPr>
            <a:lvl4pPr marL="1371754" indent="0">
              <a:buNone/>
              <a:defRPr sz="1000"/>
            </a:lvl4pPr>
            <a:lvl5pPr marL="1829006" indent="0">
              <a:buNone/>
              <a:defRPr sz="1000"/>
            </a:lvl5pPr>
            <a:lvl6pPr marL="2286257" indent="0">
              <a:buNone/>
              <a:defRPr sz="1000"/>
            </a:lvl6pPr>
            <a:lvl7pPr marL="2743507" indent="0">
              <a:buNone/>
              <a:defRPr sz="1000"/>
            </a:lvl7pPr>
            <a:lvl8pPr marL="3200760" indent="0">
              <a:buNone/>
              <a:defRPr sz="1000"/>
            </a:lvl8pPr>
            <a:lvl9pPr marL="365801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0C15839-D9C4-B3BB-CDC4-1D39BEC942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946F7F0-2DEC-9B50-3A5E-234AF3454A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ABA3AEE-4870-FB8A-894C-5AD678D8FF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122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687730-23A1-3A73-FEE6-198F8163D2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98D4E09-47B7-9550-3D68-BCB6E28EAB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92" y="987428"/>
            <a:ext cx="6172199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51" indent="0">
              <a:buNone/>
              <a:defRPr sz="2801"/>
            </a:lvl2pPr>
            <a:lvl3pPr marL="914504" indent="0">
              <a:buNone/>
              <a:defRPr sz="2401"/>
            </a:lvl3pPr>
            <a:lvl4pPr marL="1371754" indent="0">
              <a:buNone/>
              <a:defRPr sz="2000"/>
            </a:lvl4pPr>
            <a:lvl5pPr marL="1829006" indent="0">
              <a:buNone/>
              <a:defRPr sz="2000"/>
            </a:lvl5pPr>
            <a:lvl6pPr marL="2286257" indent="0">
              <a:buNone/>
              <a:defRPr sz="2000"/>
            </a:lvl6pPr>
            <a:lvl7pPr marL="2743507" indent="0">
              <a:buNone/>
              <a:defRPr sz="2000"/>
            </a:lvl7pPr>
            <a:lvl8pPr marL="3200760" indent="0">
              <a:buNone/>
              <a:defRPr sz="2000"/>
            </a:lvl8pPr>
            <a:lvl9pPr marL="365801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B30E423-E91D-33BD-DB15-DB714B6291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51" indent="0">
              <a:buNone/>
              <a:defRPr sz="1401"/>
            </a:lvl2pPr>
            <a:lvl3pPr marL="914504" indent="0">
              <a:buNone/>
              <a:defRPr sz="1199"/>
            </a:lvl3pPr>
            <a:lvl4pPr marL="1371754" indent="0">
              <a:buNone/>
              <a:defRPr sz="1000"/>
            </a:lvl4pPr>
            <a:lvl5pPr marL="1829006" indent="0">
              <a:buNone/>
              <a:defRPr sz="1000"/>
            </a:lvl5pPr>
            <a:lvl6pPr marL="2286257" indent="0">
              <a:buNone/>
              <a:defRPr sz="1000"/>
            </a:lvl6pPr>
            <a:lvl7pPr marL="2743507" indent="0">
              <a:buNone/>
              <a:defRPr sz="1000"/>
            </a:lvl7pPr>
            <a:lvl8pPr marL="3200760" indent="0">
              <a:buNone/>
              <a:defRPr sz="1000"/>
            </a:lvl8pPr>
            <a:lvl9pPr marL="365801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F7ABA8A-511F-7F07-D15B-E2BF49CC3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C513C96-2F02-04D2-1315-DAD071C57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5C1AFED-7010-4214-6928-D65679E39A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518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C4DDA90-2256-DA5A-432B-D75642FF2C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8"/>
            <a:ext cx="1051560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D80C4A4-CB0A-7557-0688-5F929D9CBB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6"/>
            <a:ext cx="10515601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B74CD4-E7B3-12EF-B0FB-F751E7BBB8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92A817-9ABE-4C08-B129-5FC354B6642B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207A05F-3B7B-D6B4-82F5-BD4250443F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3" y="6356353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066ABC8-2CC7-8795-C985-82C1BCE4FA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46051A-40AC-459B-84DA-C84C898860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177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504" rtl="0" eaLnBrk="1" latinLnBrk="0" hangingPunct="1">
        <a:lnSpc>
          <a:spcPct val="90000"/>
        </a:lnSpc>
        <a:spcBef>
          <a:spcPct val="0"/>
        </a:spcBef>
        <a:buNone/>
        <a:defRPr sz="440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25" indent="-228625" algn="l" defTabSz="91450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1" kern="1200">
          <a:solidFill>
            <a:schemeClr val="tx1"/>
          </a:solidFill>
          <a:latin typeface="+mn-lt"/>
          <a:ea typeface="+mn-ea"/>
          <a:cs typeface="+mn-cs"/>
        </a:defRPr>
      </a:lvl1pPr>
      <a:lvl2pPr marL="685879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2pPr>
      <a:lvl3pPr marL="1143128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379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631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882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2135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385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635" indent="-228625" algn="l" defTabSz="914504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51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504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754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9006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257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507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760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8010" algn="l" defTabSz="914504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39118BC-2CFD-9B67-B4D3-D0E99FAB4219}"/>
              </a:ext>
            </a:extLst>
          </p:cNvPr>
          <p:cNvSpPr txBox="1"/>
          <p:nvPr/>
        </p:nvSpPr>
        <p:spPr>
          <a:xfrm>
            <a:off x="240534" y="169321"/>
            <a:ext cx="11710932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[Additional File 1] </a:t>
            </a:r>
            <a:r>
              <a:rPr lang="en-US" altLang="ja-JP" dirty="0"/>
              <a:t>The full distribution of responses for each CM behaviors across the original four response categories by parental sex (full results in Figure 3)</a:t>
            </a:r>
            <a:r>
              <a:rPr lang="en-US" altLang="ja-JP" b="1" dirty="0"/>
              <a:t> </a:t>
            </a:r>
            <a:endParaRPr lang="en-US" sz="2000" dirty="0"/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05B26C19-969B-5097-F5A3-8D20B96D2C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158980"/>
              </p:ext>
            </p:extLst>
          </p:nvPr>
        </p:nvGraphicFramePr>
        <p:xfrm>
          <a:off x="112295" y="1033789"/>
          <a:ext cx="6256420" cy="5399215"/>
        </p:xfrm>
        <a:graphic>
          <a:graphicData uri="http://schemas.openxmlformats.org/drawingml/2006/table">
            <a:tbl>
              <a:tblPr firstRow="1" firstCol="1">
                <a:tableStyleId>{C083E6E3-FA7D-4D7B-A595-EF9225AFEA82}</a:tableStyleId>
              </a:tblPr>
              <a:tblGrid>
                <a:gridCol w="1088833">
                  <a:extLst>
                    <a:ext uri="{9D8B030D-6E8A-4147-A177-3AD203B41FA5}">
                      <a16:colId xmlns:a16="http://schemas.microsoft.com/office/drawing/2014/main" val="2983493887"/>
                    </a:ext>
                  </a:extLst>
                </a:gridCol>
                <a:gridCol w="1257231">
                  <a:extLst>
                    <a:ext uri="{9D8B030D-6E8A-4147-A177-3AD203B41FA5}">
                      <a16:colId xmlns:a16="http://schemas.microsoft.com/office/drawing/2014/main" val="2747949936"/>
                    </a:ext>
                  </a:extLst>
                </a:gridCol>
                <a:gridCol w="1303452">
                  <a:extLst>
                    <a:ext uri="{9D8B030D-6E8A-4147-A177-3AD203B41FA5}">
                      <a16:colId xmlns:a16="http://schemas.microsoft.com/office/drawing/2014/main" val="3641018635"/>
                    </a:ext>
                  </a:extLst>
                </a:gridCol>
                <a:gridCol w="1303452">
                  <a:extLst>
                    <a:ext uri="{9D8B030D-6E8A-4147-A177-3AD203B41FA5}">
                      <a16:colId xmlns:a16="http://schemas.microsoft.com/office/drawing/2014/main" val="1959034136"/>
                    </a:ext>
                  </a:extLst>
                </a:gridCol>
                <a:gridCol w="1303452">
                  <a:extLst>
                    <a:ext uri="{9D8B030D-6E8A-4147-A177-3AD203B41FA5}">
                      <a16:colId xmlns:a16="http://schemas.microsoft.com/office/drawing/2014/main" val="1053373249"/>
                    </a:ext>
                  </a:extLst>
                </a:gridCol>
              </a:tblGrid>
              <a:tr h="2242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Abuse act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frequency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Total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Mal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Femal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2486192213"/>
                  </a:ext>
                </a:extLst>
              </a:tr>
              <a:tr h="337604">
                <a:tc rowSpan="4">
                  <a:txBody>
                    <a:bodyPr/>
                    <a:lstStyle/>
                    <a:p>
                      <a:pPr algn="ctr" fontAlgn="t"/>
                      <a:r>
                        <a:rPr lang="en-US" sz="1400" u="none" strike="noStrike" dirty="0">
                          <a:effectLst/>
                        </a:rPr>
                        <a:t>Hit the child’s bod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1.ofte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50 (0.75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11 (0.92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39 (0.01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3055287052"/>
                  </a:ext>
                </a:extLst>
              </a:tr>
              <a:tr h="337604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2.sometim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255 (3.80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62 (5.19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193 (3.50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3090957980"/>
                  </a:ext>
                </a:extLst>
              </a:tr>
              <a:tr h="337604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3.rarely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809 (12.07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169 (14.15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640 (11.62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1751606160"/>
                  </a:ext>
                </a:extLst>
              </a:tr>
              <a:tr h="224253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4.never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5589 (83.38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952 (79.73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4637 (84.17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3936040495"/>
                  </a:ext>
                </a:extLst>
              </a:tr>
              <a:tr h="337604">
                <a:tc rowSpan="4">
                  <a:txBody>
                    <a:bodyPr/>
                    <a:lstStyle/>
                    <a:p>
                      <a:pPr algn="ctr" fontAlgn="t"/>
                      <a:r>
                        <a:rPr lang="en-US" sz="1400" u="none" strike="noStrike" dirty="0">
                          <a:effectLst/>
                        </a:rPr>
                        <a:t>Beat the child</a:t>
                      </a:r>
                      <a:endParaRPr lang="en-US" sz="1400" u="none" strike="noStrike" dirty="0">
                        <a:effectLst/>
                        <a:latin typeface="+mn-lt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1.ofte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16 (0.24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u="none" strike="noStrike">
                          <a:effectLst/>
                        </a:rPr>
                        <a:t> </a:t>
                      </a:r>
                      <a:r>
                        <a:rPr lang="en-US" altLang="ja-JP" sz="1400" u="none" strike="noStrike">
                          <a:effectLst/>
                        </a:rPr>
                        <a:t>8 (0.67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8 (0.15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3047149147"/>
                  </a:ext>
                </a:extLst>
              </a:tr>
              <a:tr h="337604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2.sometimes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50 (0.75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14 (1.17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36 (0.65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2711473468"/>
                  </a:ext>
                </a:extLst>
              </a:tr>
              <a:tr h="337604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3.rarel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148 (2.21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56 (4.69%) 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92 (1.67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105984606"/>
                  </a:ext>
                </a:extLst>
              </a:tr>
              <a:tr h="337604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4.never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6489 (96.81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1116 (93.47%) 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5373 (97.53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4274550976"/>
                  </a:ext>
                </a:extLst>
              </a:tr>
              <a:tr h="337604">
                <a:tc rowSpan="4">
                  <a:txBody>
                    <a:bodyPr/>
                    <a:lstStyle/>
                    <a:p>
                      <a:pPr algn="ctr" fontAlgn="t"/>
                      <a:r>
                        <a:rPr lang="en-US" sz="1400" u="none" strike="noStrike" dirty="0">
                          <a:effectLst/>
                        </a:rPr>
                        <a:t>Have a big fight in front of the child</a:t>
                      </a:r>
                      <a:endParaRPr lang="en-US" sz="1400" u="none" strike="noStrike" dirty="0">
                        <a:effectLst/>
                        <a:latin typeface="+mn-lt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1.often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32 (0.48%) 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9 (0.75%) 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u="none" strike="noStrike" dirty="0">
                          <a:effectLst/>
                        </a:rPr>
                        <a:t> </a:t>
                      </a:r>
                      <a:r>
                        <a:rPr lang="en-US" altLang="ja-JP" sz="1400" u="none" strike="noStrike" dirty="0">
                          <a:effectLst/>
                        </a:rPr>
                        <a:t>23 (0.42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2615736869"/>
                  </a:ext>
                </a:extLst>
              </a:tr>
              <a:tr h="337604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2. sometim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u="none" strike="noStrike">
                          <a:effectLst/>
                        </a:rPr>
                        <a:t> </a:t>
                      </a:r>
                      <a:r>
                        <a:rPr lang="en-US" altLang="ja-JP" sz="1400" u="none" strike="noStrike">
                          <a:effectLst/>
                        </a:rPr>
                        <a:t>153 (2.28%) 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29 (2.43%) 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124 (2.25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1183225108"/>
                  </a:ext>
                </a:extLst>
              </a:tr>
              <a:tr h="337604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3.rarely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625 (9.32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111 (9.30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514 (9.33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3507316882"/>
                  </a:ext>
                </a:extLst>
              </a:tr>
              <a:tr h="337604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4.never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5893 (87.92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1045 (87.52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4848 (88.00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3441889474"/>
                  </a:ext>
                </a:extLst>
              </a:tr>
              <a:tr h="337604">
                <a:tc rowSpan="4">
                  <a:txBody>
                    <a:bodyPr/>
                    <a:lstStyle/>
                    <a:p>
                      <a:pPr algn="ctr" fontAlgn="t"/>
                      <a:r>
                        <a:rPr lang="en-US" sz="1400" u="none" strike="noStrike" dirty="0">
                          <a:effectLst/>
                        </a:rPr>
                        <a:t>Insult the child repeatedl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1.ofte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17 (0.25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u="none" strike="noStrike">
                          <a:effectLst/>
                        </a:rPr>
                        <a:t> </a:t>
                      </a:r>
                      <a:r>
                        <a:rPr lang="en-US" altLang="ja-JP" sz="1400" u="none" strike="noStrike">
                          <a:effectLst/>
                        </a:rPr>
                        <a:t>5 (0.42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12 (0.22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2449517909"/>
                  </a:ext>
                </a:extLst>
              </a:tr>
              <a:tr h="337604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2.sometimes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73 (1.09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21 (1.76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u="none" strike="noStrike" dirty="0">
                          <a:effectLst/>
                        </a:rPr>
                        <a:t> </a:t>
                      </a:r>
                      <a:r>
                        <a:rPr lang="en-US" altLang="ja-JP" sz="1400" u="none" strike="noStrike" dirty="0">
                          <a:effectLst/>
                        </a:rPr>
                        <a:t>52 (0.94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3364537596"/>
                  </a:ext>
                </a:extLst>
              </a:tr>
              <a:tr h="337604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3.rarely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u="none" strike="noStrike" dirty="0">
                          <a:effectLst/>
                        </a:rPr>
                        <a:t> </a:t>
                      </a:r>
                      <a:r>
                        <a:rPr lang="en-US" altLang="ja-JP" sz="1400" u="none" strike="noStrike" dirty="0">
                          <a:effectLst/>
                        </a:rPr>
                        <a:t>304 (4.54%) 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56 (4.69%) 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248 (4.50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3267580210"/>
                  </a:ext>
                </a:extLst>
              </a:tr>
              <a:tr h="224253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4.never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u="none" strike="noStrike">
                          <a:effectLst/>
                        </a:rPr>
                        <a:t> </a:t>
                      </a:r>
                      <a:r>
                        <a:rPr lang="en-US" altLang="ja-JP" sz="1400" u="none" strike="noStrike">
                          <a:effectLst/>
                        </a:rPr>
                        <a:t>6309 (94.12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1112 (93.13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5197 (94.34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70060147"/>
                  </a:ext>
                </a:extLst>
              </a:tr>
            </a:tbl>
          </a:graphicData>
        </a:graphic>
      </p:graphicFrame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358F7FD6-B433-E674-C703-7E571BF775D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17422230"/>
              </p:ext>
            </p:extLst>
          </p:nvPr>
        </p:nvGraphicFramePr>
        <p:xfrm>
          <a:off x="6464969" y="1033789"/>
          <a:ext cx="5614736" cy="5399216"/>
        </p:xfrm>
        <a:graphic>
          <a:graphicData uri="http://schemas.openxmlformats.org/drawingml/2006/table">
            <a:tbl>
              <a:tblPr firstRow="1" firstCol="1">
                <a:tableStyleId>{C083E6E3-FA7D-4D7B-A595-EF9225AFEA82}</a:tableStyleId>
              </a:tblPr>
              <a:tblGrid>
                <a:gridCol w="1066381">
                  <a:extLst>
                    <a:ext uri="{9D8B030D-6E8A-4147-A177-3AD203B41FA5}">
                      <a16:colId xmlns:a16="http://schemas.microsoft.com/office/drawing/2014/main" val="2983493887"/>
                    </a:ext>
                  </a:extLst>
                </a:gridCol>
                <a:gridCol w="1282870">
                  <a:extLst>
                    <a:ext uri="{9D8B030D-6E8A-4147-A177-3AD203B41FA5}">
                      <a16:colId xmlns:a16="http://schemas.microsoft.com/office/drawing/2014/main" val="2747949936"/>
                    </a:ext>
                  </a:extLst>
                </a:gridCol>
                <a:gridCol w="1088495">
                  <a:extLst>
                    <a:ext uri="{9D8B030D-6E8A-4147-A177-3AD203B41FA5}">
                      <a16:colId xmlns:a16="http://schemas.microsoft.com/office/drawing/2014/main" val="3641018635"/>
                    </a:ext>
                  </a:extLst>
                </a:gridCol>
                <a:gridCol w="1088495">
                  <a:extLst>
                    <a:ext uri="{9D8B030D-6E8A-4147-A177-3AD203B41FA5}">
                      <a16:colId xmlns:a16="http://schemas.microsoft.com/office/drawing/2014/main" val="1959034136"/>
                    </a:ext>
                  </a:extLst>
                </a:gridCol>
                <a:gridCol w="1088495">
                  <a:extLst>
                    <a:ext uri="{9D8B030D-6E8A-4147-A177-3AD203B41FA5}">
                      <a16:colId xmlns:a16="http://schemas.microsoft.com/office/drawing/2014/main" val="1053373249"/>
                    </a:ext>
                  </a:extLst>
                </a:gridCol>
              </a:tblGrid>
              <a:tr h="1925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Abuse act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frequency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Total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Male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Female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2486192213"/>
                  </a:ext>
                </a:extLst>
              </a:tr>
              <a:tr h="324000">
                <a:tc rowSpan="4">
                  <a:txBody>
                    <a:bodyPr/>
                    <a:lstStyle/>
                    <a:p>
                      <a:pPr algn="ctr" fontAlgn="t"/>
                      <a:r>
                        <a:rPr lang="en-US" sz="1400" u="none" strike="noStrike" dirty="0">
                          <a:effectLst/>
                        </a:rPr>
                        <a:t>Shut the child outsid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1.often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u="none" strike="noStrike">
                          <a:effectLst/>
                        </a:rPr>
                        <a:t> </a:t>
                      </a:r>
                      <a:r>
                        <a:rPr lang="en-US" altLang="ja-JP" sz="1400" u="none" strike="noStrike">
                          <a:effectLst/>
                        </a:rPr>
                        <a:t>8 (0.12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4 (0.34%) 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4 (0.07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496739200"/>
                  </a:ext>
                </a:extLst>
              </a:tr>
              <a:tr h="324000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2.sometimes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u="none" strike="noStrike">
                          <a:effectLst/>
                        </a:rPr>
                        <a:t> </a:t>
                      </a:r>
                      <a:r>
                        <a:rPr lang="en-US" altLang="ja-JP" sz="1400" u="none" strike="noStrike">
                          <a:effectLst/>
                        </a:rPr>
                        <a:t>33 (0.49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u="none" strike="noStrike">
                          <a:effectLst/>
                        </a:rPr>
                        <a:t> </a:t>
                      </a:r>
                      <a:r>
                        <a:rPr lang="en-US" altLang="ja-JP" sz="1400" u="none" strike="noStrike">
                          <a:effectLst/>
                        </a:rPr>
                        <a:t>17 (1.42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16 (0.29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1511135739"/>
                  </a:ext>
                </a:extLst>
              </a:tr>
              <a:tr h="324000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3.rarely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u="none" strike="noStrike" dirty="0">
                          <a:effectLst/>
                        </a:rPr>
                        <a:t> </a:t>
                      </a:r>
                      <a:r>
                        <a:rPr lang="en-US" altLang="ja-JP" sz="1400" u="none" strike="noStrike" dirty="0">
                          <a:effectLst/>
                        </a:rPr>
                        <a:t>107 (1.60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46 (3.85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61 (1.11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2078859752"/>
                  </a:ext>
                </a:extLst>
              </a:tr>
              <a:tr h="324000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4.never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u="none" strike="noStrike">
                          <a:effectLst/>
                        </a:rPr>
                        <a:t> </a:t>
                      </a:r>
                      <a:r>
                        <a:rPr lang="en-US" altLang="ja-JP" sz="1400" u="none" strike="noStrike">
                          <a:effectLst/>
                        </a:rPr>
                        <a:t>6555 (97.79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1127 (94.39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5428 (98.53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2080187436"/>
                  </a:ext>
                </a:extLst>
              </a:tr>
              <a:tr h="324000">
                <a:tc rowSpan="4">
                  <a:txBody>
                    <a:bodyPr/>
                    <a:lstStyle/>
                    <a:p>
                      <a:pPr algn="ctr" fontAlgn="t"/>
                      <a:r>
                        <a:rPr lang="en-US" sz="1400" u="none" strike="noStrike" dirty="0">
                          <a:effectLst/>
                        </a:rPr>
                        <a:t>Leave the child alone in the house at night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1.ofte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5 (0.07%) 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3 (0.25%) 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2 (0.04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3954885130"/>
                  </a:ext>
                </a:extLst>
              </a:tr>
              <a:tr h="324000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2.sometimes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26 (0.39%) 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13 (1.09%) 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13 (0.24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1072681963"/>
                  </a:ext>
                </a:extLst>
              </a:tr>
              <a:tr h="324000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3.rarel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49 (0.73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28 (2.35%) 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21 (0.38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537910046"/>
                  </a:ext>
                </a:extLst>
              </a:tr>
              <a:tr h="324000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4.never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6623 (98.81%) 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1150 (96.31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5473 (99.35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4149806627"/>
                  </a:ext>
                </a:extLst>
              </a:tr>
              <a:tr h="324000">
                <a:tc rowSpan="4">
                  <a:txBody>
                    <a:bodyPr/>
                    <a:lstStyle/>
                    <a:p>
                      <a:pPr algn="ctr" fontAlgn="t"/>
                      <a:r>
                        <a:rPr lang="en-US" sz="1400" u="none" strike="noStrike" dirty="0">
                          <a:effectLst/>
                        </a:rPr>
                        <a:t>Do not feed the child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1.often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4 (0.06%) 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3 (0.25%) 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1 (0.02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3316498996"/>
                  </a:ext>
                </a:extLst>
              </a:tr>
              <a:tr h="324000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2.sometim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26 (0.39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16 (1.34%) 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10 (0.18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2800730057"/>
                  </a:ext>
                </a:extLst>
              </a:tr>
              <a:tr h="324000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3.rarel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45 (0.67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u="none" strike="noStrike" dirty="0">
                          <a:effectLst/>
                        </a:rPr>
                        <a:t> </a:t>
                      </a:r>
                      <a:r>
                        <a:rPr lang="en-US" altLang="ja-JP" sz="1400" u="none" strike="noStrike" dirty="0">
                          <a:effectLst/>
                        </a:rPr>
                        <a:t>27 (2.26%) 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18 (0.33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4263949453"/>
                  </a:ext>
                </a:extLst>
              </a:tr>
              <a:tr h="324000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4.never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6628 (98.88%) 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1148 (96.15%) 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5480 (99.47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3250931417"/>
                  </a:ext>
                </a:extLst>
              </a:tr>
              <a:tr h="324000">
                <a:tc rowSpan="4">
                  <a:txBody>
                    <a:bodyPr/>
                    <a:lstStyle/>
                    <a:p>
                      <a:pPr algn="ctr" fontAlgn="t"/>
                      <a:r>
                        <a:rPr lang="en-US" sz="1400" u="none" strike="noStrike" dirty="0">
                          <a:effectLst/>
                        </a:rPr>
                        <a:t>Smoking in front of the child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1.ofte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75 (1.12%) 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23 (1.93%)  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52 (0.94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867127392"/>
                  </a:ext>
                </a:extLst>
              </a:tr>
              <a:tr h="324000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2.sometimes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400" u="none" strike="noStrike">
                          <a:effectLst/>
                        </a:rPr>
                        <a:t> </a:t>
                      </a:r>
                      <a:r>
                        <a:rPr lang="en-US" altLang="ja-JP" sz="1400" u="none" strike="noStrike">
                          <a:effectLst/>
                        </a:rPr>
                        <a:t>84 (1.25%)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23 (1.93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61 (1.11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1107403943"/>
                  </a:ext>
                </a:extLst>
              </a:tr>
              <a:tr h="324000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3.rarely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</a:rPr>
                        <a:t>155 (2.31%) 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60 (5.03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95 (1.72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2055441234"/>
                  </a:ext>
                </a:extLst>
              </a:tr>
              <a:tr h="324000">
                <a:tc vMerge="1">
                  <a:txBody>
                    <a:bodyPr/>
                    <a:lstStyle/>
                    <a:p>
                      <a:pPr algn="l" fontAlgn="ctr"/>
                      <a:endParaRPr lang="ja-JP" alt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4.never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6389 (95.32%) 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1088 (91.12%) 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</a:rPr>
                        <a:t>5301 (96.22%)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1856" marR="1856" marT="1856" marB="0" anchor="ctr"/>
                </a:tc>
                <a:extLst>
                  <a:ext uri="{0D108BD9-81ED-4DB2-BD59-A6C34878D82A}">
                    <a16:rowId xmlns:a16="http://schemas.microsoft.com/office/drawing/2014/main" val="132946597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483853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670</TotalTime>
  <Words>580</Words>
  <Application>Microsoft Office PowerPoint</Application>
  <PresentationFormat>ワイド画面</PresentationFormat>
  <Paragraphs>14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ho Sodeno</dc:creator>
  <cp:lastModifiedBy>袖野 美穂/SODENO Miho</cp:lastModifiedBy>
  <cp:revision>57</cp:revision>
  <dcterms:created xsi:type="dcterms:W3CDTF">2023-04-12T15:32:35Z</dcterms:created>
  <dcterms:modified xsi:type="dcterms:W3CDTF">2025-07-07T17:14:53Z</dcterms:modified>
</cp:coreProperties>
</file>